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7" userDrawn="1">
          <p15:clr>
            <a:srgbClr val="A4A3A4"/>
          </p15:clr>
        </p15:guide>
        <p15:guide id="2" pos="9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29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2082" y="18"/>
      </p:cViewPr>
      <p:guideLst>
        <p:guide orient="horz" pos="1927"/>
        <p:guide pos="9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38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49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531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227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098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766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8995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384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6205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186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4911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560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854644C-DAB8-4B49-AD97-B775FAE82D5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069" r="40069"/>
          <a:stretch/>
        </p:blipFill>
        <p:spPr>
          <a:xfrm>
            <a:off x="1667592" y="892278"/>
            <a:ext cx="1552598" cy="116444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71B34F5-705C-4E42-AEFE-21131555860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069" r="40069"/>
          <a:stretch/>
        </p:blipFill>
        <p:spPr>
          <a:xfrm>
            <a:off x="1667592" y="2096659"/>
            <a:ext cx="1552598" cy="1164449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25E26ABA-C26B-48CF-A97C-B4324CCFF7A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65" t="39765"/>
          <a:stretch/>
        </p:blipFill>
        <p:spPr>
          <a:xfrm>
            <a:off x="3257637" y="902127"/>
            <a:ext cx="1539466" cy="11546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DC52CF18-D351-4301-8C39-B4DBFBBED87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43" t="40043"/>
          <a:stretch/>
        </p:blipFill>
        <p:spPr>
          <a:xfrm>
            <a:off x="3257637" y="2096659"/>
            <a:ext cx="1548899" cy="1161674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F0FCD58E-04F1-46C0-9D09-58A2A715B40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3" t="39702" r="38419"/>
          <a:stretch/>
        </p:blipFill>
        <p:spPr>
          <a:xfrm>
            <a:off x="3263554" y="3335888"/>
            <a:ext cx="1562100" cy="1171575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4DFDD663-AB67-4419-9F60-1781B6C6F7A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7" t="39946" r="38449"/>
          <a:stretch/>
        </p:blipFill>
        <p:spPr>
          <a:xfrm>
            <a:off x="3265464" y="4540969"/>
            <a:ext cx="1555750" cy="115485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F51A1860-4922-403F-AFCE-76B24A597F6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040" r="39045" b="18005"/>
          <a:stretch/>
        </p:blipFill>
        <p:spPr>
          <a:xfrm>
            <a:off x="1667592" y="3335888"/>
            <a:ext cx="1557867" cy="11684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595DF52-3792-420C-A223-69E8D56CA737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677" r="40395" b="18718"/>
          <a:stretch/>
        </p:blipFill>
        <p:spPr>
          <a:xfrm>
            <a:off x="1667592" y="4540969"/>
            <a:ext cx="1539811" cy="1154858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>
            <a:off x="2200036" y="616378"/>
            <a:ext cx="654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677724" y="616378"/>
            <a:ext cx="7184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+pue50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920558" y="1359250"/>
            <a:ext cx="4956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kumimoji="1" lang="en-US" altLang="ja-JP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816698" y="2561451"/>
            <a:ext cx="862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kumimoji="1" lang="en-US" altLang="ja-JP" sz="1200" b="1" dirty="0">
                <a:latin typeface="Symbol" panose="05050102010706020507" pitchFamily="18" charset="2"/>
                <a:cs typeface="Arial" panose="020B0604020202020204" pitchFamily="34" charset="0"/>
              </a:rPr>
              <a:t>a/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コネクタ 15"/>
          <p:cNvCxnSpPr/>
          <p:nvPr/>
        </p:nvCxnSpPr>
        <p:spPr>
          <a:xfrm>
            <a:off x="1248066" y="3298590"/>
            <a:ext cx="3524026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920558" y="374541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kumimoji="1" lang="en-US" altLang="ja-JP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816698" y="4947613"/>
            <a:ext cx="84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n-US" altLang="ja-JP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200" b="1" dirty="0">
                <a:latin typeface="Symbol" panose="05050102010706020507" pitchFamily="18" charset="2"/>
                <a:cs typeface="Arial" panose="020B0604020202020204" pitchFamily="34" charset="0"/>
              </a:rPr>
              <a:t>/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59657" y="420914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3 Fig.</a:t>
            </a:r>
            <a:endParaRPr kumimoji="1" lang="ja-JP" altLang="en-US" b="1" dirty="0"/>
          </a:p>
        </p:txBody>
      </p:sp>
      <p:sp>
        <p:nvSpPr>
          <p:cNvPr id="2" name="正方形/長方形 1"/>
          <p:cNvSpPr/>
          <p:nvPr/>
        </p:nvSpPr>
        <p:spPr>
          <a:xfrm>
            <a:off x="237837" y="6156485"/>
            <a:ext cx="6424219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dirty="0"/>
              <a:t>S3 Fig. The effect of puerarin on the translocation of estrogen receptors in young NHDFs. Young NHDFs with or without 50 </a:t>
            </a:r>
            <a:r>
              <a:rPr lang="en-US" altLang="ja-JP" sz="1600" dirty="0" err="1"/>
              <a:t>microM</a:t>
            </a:r>
            <a:r>
              <a:rPr lang="en-US" altLang="ja-JP" sz="1600" dirty="0"/>
              <a:t> puerarin (+</a:t>
            </a:r>
            <a:r>
              <a:rPr lang="en-US" altLang="ja-JP" sz="1600" dirty="0" err="1"/>
              <a:t>pue</a:t>
            </a:r>
            <a:r>
              <a:rPr lang="en-US" altLang="ja-JP" sz="1600" dirty="0"/>
              <a:t> 50) were stained for </a:t>
            </a:r>
            <a:r>
              <a:rPr lang="en-US" altLang="ja-JP" sz="1600" dirty="0" err="1"/>
              <a:t>ER#a</a:t>
            </a:r>
            <a:r>
              <a:rPr lang="en-US" altLang="ja-JP" sz="1600" dirty="0"/>
              <a:t> (upper) or </a:t>
            </a:r>
            <a:r>
              <a:rPr lang="en-US" altLang="ja-JP" sz="1600" dirty="0" err="1"/>
              <a:t>ER#b</a:t>
            </a:r>
            <a:r>
              <a:rPr lang="en-US" altLang="ja-JP" sz="1600" dirty="0"/>
              <a:t> (lower) by the </a:t>
            </a:r>
            <a:r>
              <a:rPr lang="en-US" altLang="ja-JP" sz="1600" dirty="0" err="1"/>
              <a:t>immunocytochemical</a:t>
            </a:r>
            <a:r>
              <a:rPr lang="en-US" altLang="ja-JP" sz="1600" dirty="0"/>
              <a:t> method.  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462127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50</TotalTime>
  <Words>64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テーマ</vt:lpstr>
      <vt:lpstr>PowerPoint Presentation</vt:lpstr>
    </vt:vector>
  </TitlesOfParts>
  <Company>福井県立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井県立大学</dc:creator>
  <cp:lastModifiedBy>chn off28</cp:lastModifiedBy>
  <cp:revision>130</cp:revision>
  <cp:lastPrinted>2020-03-25T12:54:27Z</cp:lastPrinted>
  <dcterms:created xsi:type="dcterms:W3CDTF">2020-02-05T00:21:06Z</dcterms:created>
  <dcterms:modified xsi:type="dcterms:W3CDTF">2021-04-16T05:46:43Z</dcterms:modified>
</cp:coreProperties>
</file>